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2824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3331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225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3997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2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030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9818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5618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2238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760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281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C4C57D-111C-4063-91D5-C9B1E24F4803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52A94-D13A-4E29-935D-1CF9F2EB19F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8931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1200559"/>
              </p:ext>
            </p:extLst>
          </p:nvPr>
        </p:nvGraphicFramePr>
        <p:xfrm>
          <a:off x="3308446" y="250061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1" name="SPW 12.0 Graph" r:id="rId3" imgW="5276843" imgH="4029134" progId="SigmaPlotGraphicObject.11">
                  <p:embed/>
                </p:oleObj>
              </mc:Choice>
              <mc:Fallback>
                <p:oleObj name="SPW 12.0 Graph" r:id="rId3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08446" y="250061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7739145"/>
              </p:ext>
            </p:extLst>
          </p:nvPr>
        </p:nvGraphicFramePr>
        <p:xfrm>
          <a:off x="5911828" y="250061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2" name="SPW 12.0 Graph" r:id="rId5" imgW="5276843" imgH="4029134" progId="SigmaPlotGraphicObject.11">
                  <p:embed/>
                </p:oleObj>
              </mc:Choice>
              <mc:Fallback>
                <p:oleObj name="SPW 12.0 Graph" r:id="rId5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11828" y="250061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1082958"/>
              </p:ext>
            </p:extLst>
          </p:nvPr>
        </p:nvGraphicFramePr>
        <p:xfrm>
          <a:off x="8626744" y="250061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name="SPW 12.0 Graph" r:id="rId7" imgW="5276843" imgH="4029134" progId="SigmaPlotGraphicObject.11">
                  <p:embed/>
                </p:oleObj>
              </mc:Choice>
              <mc:Fallback>
                <p:oleObj name="SPW 12.0 Graph" r:id="rId7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26744" y="250061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7896481"/>
              </p:ext>
            </p:extLst>
          </p:nvPr>
        </p:nvGraphicFramePr>
        <p:xfrm>
          <a:off x="791229" y="218417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SPW 12.0 Graph" r:id="rId9" imgW="5276843" imgH="4029134" progId="SigmaPlotGraphicObject.11">
                  <p:embed/>
                </p:oleObj>
              </mc:Choice>
              <mc:Fallback>
                <p:oleObj name="SPW 12.0 Graph" r:id="rId9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91229" y="218417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6597963"/>
              </p:ext>
            </p:extLst>
          </p:nvPr>
        </p:nvGraphicFramePr>
        <p:xfrm>
          <a:off x="3308446" y="218417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SPW 12.0 Graph" r:id="rId11" imgW="5276843" imgH="4029134" progId="SigmaPlotGraphicObject.11">
                  <p:embed/>
                </p:oleObj>
              </mc:Choice>
              <mc:Fallback>
                <p:oleObj name="SPW 12.0 Graph" r:id="rId11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08446" y="218417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2935643"/>
              </p:ext>
            </p:extLst>
          </p:nvPr>
        </p:nvGraphicFramePr>
        <p:xfrm>
          <a:off x="5911828" y="218417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SPW 12.0 Graph" r:id="rId13" imgW="5276843" imgH="4029134" progId="SigmaPlotGraphicObject.11">
                  <p:embed/>
                </p:oleObj>
              </mc:Choice>
              <mc:Fallback>
                <p:oleObj name="SPW 12.0 Graph" r:id="rId13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911828" y="218417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4590267"/>
              </p:ext>
            </p:extLst>
          </p:nvPr>
        </p:nvGraphicFramePr>
        <p:xfrm>
          <a:off x="8626744" y="218417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SPW 12.0 Graph" r:id="rId15" imgW="5276843" imgH="4029134" progId="SigmaPlotGraphicObject.11">
                  <p:embed/>
                </p:oleObj>
              </mc:Choice>
              <mc:Fallback>
                <p:oleObj name="SPW 12.0 Graph" r:id="rId15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8626744" y="218417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5912745"/>
              </p:ext>
            </p:extLst>
          </p:nvPr>
        </p:nvGraphicFramePr>
        <p:xfrm>
          <a:off x="791229" y="410895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SPW 12.0 Graph" r:id="rId17" imgW="5276843" imgH="4029134" progId="SigmaPlotGraphicObject.11">
                  <p:embed/>
                </p:oleObj>
              </mc:Choice>
              <mc:Fallback>
                <p:oleObj name="SPW 12.0 Graph" r:id="rId17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91229" y="410895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5477962"/>
              </p:ext>
            </p:extLst>
          </p:nvPr>
        </p:nvGraphicFramePr>
        <p:xfrm>
          <a:off x="3308446" y="410895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9" name="SPW 12.0 Graph" r:id="rId19" imgW="5276843" imgH="4029134" progId="SigmaPlotGraphicObject.11">
                  <p:embed/>
                </p:oleObj>
              </mc:Choice>
              <mc:Fallback>
                <p:oleObj name="SPW 12.0 Graph" r:id="rId19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308446" y="410895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6633986"/>
              </p:ext>
            </p:extLst>
          </p:nvPr>
        </p:nvGraphicFramePr>
        <p:xfrm>
          <a:off x="5911828" y="410895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" name="SPW 12.0 Graph" r:id="rId21" imgW="5276843" imgH="4029134" progId="SigmaPlotGraphicObject.11">
                  <p:embed/>
                </p:oleObj>
              </mc:Choice>
              <mc:Fallback>
                <p:oleObj name="SPW 12.0 Graph" r:id="rId21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911828" y="410895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6857268"/>
              </p:ext>
            </p:extLst>
          </p:nvPr>
        </p:nvGraphicFramePr>
        <p:xfrm>
          <a:off x="8626744" y="4108952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SPW 12.0 Graph" r:id="rId23" imgW="5276843" imgH="4029134" progId="SigmaPlotGraphicObject.11">
                  <p:embed/>
                </p:oleObj>
              </mc:Choice>
              <mc:Fallback>
                <p:oleObj name="SPW 12.0 Graph" r:id="rId23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626744" y="4108952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feld 17"/>
          <p:cNvSpPr txBox="1"/>
          <p:nvPr/>
        </p:nvSpPr>
        <p:spPr>
          <a:xfrm>
            <a:off x="80845" y="-16630"/>
            <a:ext cx="1548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ig. 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791229" y="6388402"/>
            <a:ext cx="108627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. 1: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N-PAG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fil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f individual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A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uni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mo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y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BN-PAG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lic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x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lso Fig. 1E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x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 Not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Objek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2202897"/>
              </p:ext>
            </p:extLst>
          </p:nvPr>
        </p:nvGraphicFramePr>
        <p:xfrm>
          <a:off x="835180" y="244449"/>
          <a:ext cx="2590859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SPW 12.0 Graph" r:id="rId25" imgW="5181717" imgH="4029134" progId="SigmaPlotGraphicObject.11">
                  <p:embed/>
                </p:oleObj>
              </mc:Choice>
              <mc:Fallback>
                <p:oleObj name="SPW 12.0 Graph" r:id="rId25" imgW="5181717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835180" y="244449"/>
                        <a:ext cx="2590859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feld 20"/>
          <p:cNvSpPr txBox="1"/>
          <p:nvPr/>
        </p:nvSpPr>
        <p:spPr>
          <a:xfrm>
            <a:off x="5103518" y="6132850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N-PAGE Gel slice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 rot="16200000">
            <a:off x="-148321" y="3479791"/>
            <a:ext cx="1479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r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undanc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mo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0378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Breitbild</PresentationFormat>
  <Paragraphs>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SPW 12.0 Graph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cha</dc:creator>
  <cp:lastModifiedBy>Sacha</cp:lastModifiedBy>
  <cp:revision>6</cp:revision>
  <dcterms:created xsi:type="dcterms:W3CDTF">2019-01-28T15:36:46Z</dcterms:created>
  <dcterms:modified xsi:type="dcterms:W3CDTF">2019-01-29T08:09:02Z</dcterms:modified>
</cp:coreProperties>
</file>